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obert peuß" initials="rp" lastIdx="1" clrIdx="0">
    <p:extLst>
      <p:ext uri="{19B8F6BF-5375-455C-9EA6-DF929625EA0E}">
        <p15:presenceInfo xmlns:p15="http://schemas.microsoft.com/office/powerpoint/2012/main" userId="b8a5042eed49ea05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00" d="100"/>
          <a:sy n="100" d="100"/>
        </p:scale>
        <p:origin x="72" y="-4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commentAuthors" Target="commentAuthor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541B2-80F8-42B8-9785-40F7365599AD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F997-29DE-457F-8FC9-9A31CD12B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5033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541B2-80F8-42B8-9785-40F7365599AD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F997-29DE-457F-8FC9-9A31CD12B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262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541B2-80F8-42B8-9785-40F7365599AD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F997-29DE-457F-8FC9-9A31CD12B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6937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541B2-80F8-42B8-9785-40F7365599AD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F997-29DE-457F-8FC9-9A31CD12B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7722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541B2-80F8-42B8-9785-40F7365599AD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F997-29DE-457F-8FC9-9A31CD12B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0331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541B2-80F8-42B8-9785-40F7365599AD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F997-29DE-457F-8FC9-9A31CD12B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01291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541B2-80F8-42B8-9785-40F7365599AD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F997-29DE-457F-8FC9-9A31CD12B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1918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541B2-80F8-42B8-9785-40F7365599AD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F997-29DE-457F-8FC9-9A31CD12B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7580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541B2-80F8-42B8-9785-40F7365599AD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F997-29DE-457F-8FC9-9A31CD12B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42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541B2-80F8-42B8-9785-40F7365599AD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F997-29DE-457F-8FC9-9A31CD12B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399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541B2-80F8-42B8-9785-40F7365599AD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F997-29DE-457F-8FC9-9A31CD12B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08840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1541B2-80F8-42B8-9785-40F7365599AD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86F997-29DE-457F-8FC9-9A31CD12B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6264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344632" y="107131"/>
            <a:ext cx="4261132" cy="987984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34974EE-5E19-4733-B5B9-E768A13DC5BE}"/>
              </a:ext>
            </a:extLst>
          </p:cNvPr>
          <p:cNvSpPr txBox="1"/>
          <p:nvPr/>
        </p:nvSpPr>
        <p:spPr>
          <a:xfrm>
            <a:off x="76200" y="723900"/>
            <a:ext cx="31337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1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ublet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9C2B5CD-5BC3-4F90-99FC-C63D4B2CEB72}"/>
              </a:ext>
            </a:extLst>
          </p:cNvPr>
          <p:cNvSpPr txBox="1"/>
          <p:nvPr/>
        </p:nvSpPr>
        <p:spPr>
          <a:xfrm>
            <a:off x="76201" y="1619250"/>
            <a:ext cx="31337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relative abundance: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6601</a:t>
            </a:r>
          </a:p>
        </p:txBody>
      </p:sp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344632" y="107131"/>
            <a:ext cx="4261132" cy="987984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FCF8591-B7D0-4E90-817B-3FC078E75061}"/>
              </a:ext>
            </a:extLst>
          </p:cNvPr>
          <p:cNvSpPr txBox="1"/>
          <p:nvPr/>
        </p:nvSpPr>
        <p:spPr>
          <a:xfrm>
            <a:off x="76200" y="723900"/>
            <a:ext cx="31337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10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ythrocyte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B2F5C55-A67E-43A2-BBCD-797CE18D25A8}"/>
              </a:ext>
            </a:extLst>
          </p:cNvPr>
          <p:cNvSpPr txBox="1"/>
          <p:nvPr/>
        </p:nvSpPr>
        <p:spPr>
          <a:xfrm>
            <a:off x="76201" y="1619250"/>
            <a:ext cx="31337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relative abundance: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3321</a:t>
            </a:r>
          </a:p>
        </p:txBody>
      </p:sp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344632" y="107131"/>
            <a:ext cx="4261132" cy="987984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1B1E59B-58F7-4F0D-A5F5-D540F112918D}"/>
              </a:ext>
            </a:extLst>
          </p:cNvPr>
          <p:cNvSpPr txBox="1"/>
          <p:nvPr/>
        </p:nvSpPr>
        <p:spPr>
          <a:xfrm>
            <a:off x="76200" y="723900"/>
            <a:ext cx="31337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11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myelocyte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D35B789-5F7C-4D60-89B2-D31D9FCD453D}"/>
              </a:ext>
            </a:extLst>
          </p:cNvPr>
          <p:cNvSpPr txBox="1"/>
          <p:nvPr/>
        </p:nvSpPr>
        <p:spPr>
          <a:xfrm>
            <a:off x="76201" y="1619250"/>
            <a:ext cx="31337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relative abundance: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72185</a:t>
            </a:r>
          </a:p>
        </p:txBody>
      </p:sp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344632" y="107131"/>
            <a:ext cx="4261132" cy="987984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4163983-F524-48B8-9F92-964DA587F995}"/>
              </a:ext>
            </a:extLst>
          </p:cNvPr>
          <p:cNvSpPr txBox="1"/>
          <p:nvPr/>
        </p:nvSpPr>
        <p:spPr>
          <a:xfrm>
            <a:off x="76200" y="723900"/>
            <a:ext cx="31337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12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ythrocyte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CB6505C-26AF-4D36-A646-301DD8BFAFB5}"/>
              </a:ext>
            </a:extLst>
          </p:cNvPr>
          <p:cNvSpPr txBox="1"/>
          <p:nvPr/>
        </p:nvSpPr>
        <p:spPr>
          <a:xfrm>
            <a:off x="76201" y="1619250"/>
            <a:ext cx="31337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relative abundance: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5433</a:t>
            </a:r>
          </a:p>
        </p:txBody>
      </p:sp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344632" y="107131"/>
            <a:ext cx="4261132" cy="987984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ED8BA74-369B-4F1E-8443-A32C47BEE2FD}"/>
              </a:ext>
            </a:extLst>
          </p:cNvPr>
          <p:cNvSpPr txBox="1"/>
          <p:nvPr/>
        </p:nvSpPr>
        <p:spPr>
          <a:xfrm>
            <a:off x="76200" y="723900"/>
            <a:ext cx="31337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13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nocytic Cell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7E3ACD8-8FFF-4CDB-B9C0-A791FA7F8D62}"/>
              </a:ext>
            </a:extLst>
          </p:cNvPr>
          <p:cNvSpPr txBox="1"/>
          <p:nvPr/>
        </p:nvSpPr>
        <p:spPr>
          <a:xfrm>
            <a:off x="76201" y="1619250"/>
            <a:ext cx="31337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relative abundance: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12786</a:t>
            </a:r>
          </a:p>
        </p:txBody>
      </p:sp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344632" y="107131"/>
            <a:ext cx="4261132" cy="987984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F282440-8207-488C-92A6-C6873A32B2BD}"/>
              </a:ext>
            </a:extLst>
          </p:cNvPr>
          <p:cNvSpPr txBox="1"/>
          <p:nvPr/>
        </p:nvSpPr>
        <p:spPr>
          <a:xfrm>
            <a:off x="76200" y="723900"/>
            <a:ext cx="31337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14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utrophil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0545216-C4DB-4A0F-A438-C4A19B19DE2C}"/>
              </a:ext>
            </a:extLst>
          </p:cNvPr>
          <p:cNvSpPr txBox="1"/>
          <p:nvPr/>
        </p:nvSpPr>
        <p:spPr>
          <a:xfrm>
            <a:off x="76201" y="1619250"/>
            <a:ext cx="31337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relative abundance: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64426</a:t>
            </a:r>
          </a:p>
        </p:txBody>
      </p:sp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344632" y="107131"/>
            <a:ext cx="4261132" cy="987984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DC20B89-58AE-4986-BAC8-771384207B67}"/>
              </a:ext>
            </a:extLst>
          </p:cNvPr>
          <p:cNvSpPr txBox="1"/>
          <p:nvPr/>
        </p:nvSpPr>
        <p:spPr>
          <a:xfrm>
            <a:off x="76200" y="723900"/>
            <a:ext cx="31337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15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ublet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E042528-BD70-4EDC-88F6-66C21BD114BE}"/>
              </a:ext>
            </a:extLst>
          </p:cNvPr>
          <p:cNvSpPr txBox="1"/>
          <p:nvPr/>
        </p:nvSpPr>
        <p:spPr>
          <a:xfrm>
            <a:off x="76201" y="1619250"/>
            <a:ext cx="31337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relative abundance: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4966</a:t>
            </a:r>
          </a:p>
        </p:txBody>
      </p:sp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344632" y="107131"/>
            <a:ext cx="4261132" cy="987984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899CC3D-515E-4AF4-A5E6-205261CE5130}"/>
              </a:ext>
            </a:extLst>
          </p:cNvPr>
          <p:cNvSpPr txBox="1"/>
          <p:nvPr/>
        </p:nvSpPr>
        <p:spPr>
          <a:xfrm>
            <a:off x="76200" y="723900"/>
            <a:ext cx="313372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16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no-/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ranulo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 Promyelocytic Cell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C0F45C6-3C8C-44D1-AED2-F57AE4AE68C2}"/>
              </a:ext>
            </a:extLst>
          </p:cNvPr>
          <p:cNvSpPr txBox="1"/>
          <p:nvPr/>
        </p:nvSpPr>
        <p:spPr>
          <a:xfrm>
            <a:off x="76201" y="1619250"/>
            <a:ext cx="31337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relative abundance: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85896</a:t>
            </a:r>
          </a:p>
        </p:txBody>
      </p:sp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344632" y="107131"/>
            <a:ext cx="4261132" cy="987984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9847211-3327-4EEA-921E-0358018C391E}"/>
              </a:ext>
            </a:extLst>
          </p:cNvPr>
          <p:cNvSpPr txBox="1"/>
          <p:nvPr/>
        </p:nvSpPr>
        <p:spPr>
          <a:xfrm>
            <a:off x="76200" y="723900"/>
            <a:ext cx="31337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17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ythrocyte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61D6CA8-96C0-4C81-9D4D-E7E5430FC924}"/>
              </a:ext>
            </a:extLst>
          </p:cNvPr>
          <p:cNvSpPr txBox="1"/>
          <p:nvPr/>
        </p:nvSpPr>
        <p:spPr>
          <a:xfrm>
            <a:off x="76201" y="1619250"/>
            <a:ext cx="31337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relative abundance: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4651</a:t>
            </a:r>
          </a:p>
        </p:txBody>
      </p:sp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344632" y="107131"/>
            <a:ext cx="4261132" cy="987984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4005181-0F66-42B3-A7BF-F20F17ADDF68}"/>
              </a:ext>
            </a:extLst>
          </p:cNvPr>
          <p:cNvSpPr txBox="1"/>
          <p:nvPr/>
        </p:nvSpPr>
        <p:spPr>
          <a:xfrm>
            <a:off x="76200" y="723900"/>
            <a:ext cx="31337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18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genitor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21EF95E-2CB5-439C-B4B4-3B76DF389DDA}"/>
              </a:ext>
            </a:extLst>
          </p:cNvPr>
          <p:cNvSpPr txBox="1"/>
          <p:nvPr/>
        </p:nvSpPr>
        <p:spPr>
          <a:xfrm>
            <a:off x="76201" y="1619250"/>
            <a:ext cx="31337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relative abundance: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7454</a:t>
            </a:r>
          </a:p>
        </p:txBody>
      </p:sp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344632" y="107131"/>
            <a:ext cx="4261132" cy="987984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AA9B058-7DC3-4EDB-8917-ABCD85264678}"/>
              </a:ext>
            </a:extLst>
          </p:cNvPr>
          <p:cNvSpPr txBox="1"/>
          <p:nvPr/>
        </p:nvSpPr>
        <p:spPr>
          <a:xfrm>
            <a:off x="76200" y="723900"/>
            <a:ext cx="31337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19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ymphocyte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331310A-AB09-4317-A8B9-D2C8E5B4E232}"/>
              </a:ext>
            </a:extLst>
          </p:cNvPr>
          <p:cNvSpPr txBox="1"/>
          <p:nvPr/>
        </p:nvSpPr>
        <p:spPr>
          <a:xfrm>
            <a:off x="76201" y="1619250"/>
            <a:ext cx="31337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relative abundance: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13558</a:t>
            </a:r>
          </a:p>
        </p:txBody>
      </p:sp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344632" y="107131"/>
            <a:ext cx="4261132" cy="987984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6C9BAFC-2CC4-4A79-BB99-2F843D6114F0}"/>
              </a:ext>
            </a:extLst>
          </p:cNvPr>
          <p:cNvSpPr txBox="1"/>
          <p:nvPr/>
        </p:nvSpPr>
        <p:spPr>
          <a:xfrm>
            <a:off x="76200" y="723900"/>
            <a:ext cx="31337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2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ast Cells / Promyelocyte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DE47741-A006-49F0-B206-D654E4F207B3}"/>
              </a:ext>
            </a:extLst>
          </p:cNvPr>
          <p:cNvSpPr txBox="1"/>
          <p:nvPr/>
        </p:nvSpPr>
        <p:spPr>
          <a:xfrm>
            <a:off x="76201" y="1619250"/>
            <a:ext cx="31337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relative abundance: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52128</a:t>
            </a:r>
          </a:p>
        </p:txBody>
      </p:sp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344632" y="107131"/>
            <a:ext cx="4261132" cy="987984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349F28F-3474-4A69-9E63-F528A86A31A3}"/>
              </a:ext>
            </a:extLst>
          </p:cNvPr>
          <p:cNvSpPr txBox="1"/>
          <p:nvPr/>
        </p:nvSpPr>
        <p:spPr>
          <a:xfrm>
            <a:off x="76200" y="723900"/>
            <a:ext cx="31337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20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ad Cell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3E1A01F-7DBB-48A5-9FB0-A8E27330B3F7}"/>
              </a:ext>
            </a:extLst>
          </p:cNvPr>
          <p:cNvSpPr txBox="1"/>
          <p:nvPr/>
        </p:nvSpPr>
        <p:spPr>
          <a:xfrm>
            <a:off x="76201" y="1619250"/>
            <a:ext cx="31337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relative abundance: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5261</a:t>
            </a:r>
          </a:p>
        </p:txBody>
      </p:sp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344632" y="107131"/>
            <a:ext cx="4261132" cy="987984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ED414B1-F3AF-44CC-8EC5-9F803B380115}"/>
              </a:ext>
            </a:extLst>
          </p:cNvPr>
          <p:cNvSpPr txBox="1"/>
          <p:nvPr/>
        </p:nvSpPr>
        <p:spPr>
          <a:xfrm>
            <a:off x="76200" y="723900"/>
            <a:ext cx="31337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21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ythrocyte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326AC71-297B-4468-AA75-A427DE55E23A}"/>
              </a:ext>
            </a:extLst>
          </p:cNvPr>
          <p:cNvSpPr txBox="1"/>
          <p:nvPr/>
        </p:nvSpPr>
        <p:spPr>
          <a:xfrm>
            <a:off x="76201" y="1619250"/>
            <a:ext cx="31337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relative abundance: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5921</a:t>
            </a:r>
          </a:p>
        </p:txBody>
      </p:sp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344632" y="107131"/>
            <a:ext cx="4261132" cy="987984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993F916-B683-48F4-8793-1AF55B189A8B}"/>
              </a:ext>
            </a:extLst>
          </p:cNvPr>
          <p:cNvSpPr txBox="1"/>
          <p:nvPr/>
        </p:nvSpPr>
        <p:spPr>
          <a:xfrm>
            <a:off x="76200" y="723900"/>
            <a:ext cx="31337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3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ythrocyte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F2F765B-83E0-4C7E-9018-5D026F42AE84}"/>
              </a:ext>
            </a:extLst>
          </p:cNvPr>
          <p:cNvSpPr txBox="1"/>
          <p:nvPr/>
        </p:nvSpPr>
        <p:spPr>
          <a:xfrm>
            <a:off x="76201" y="1619250"/>
            <a:ext cx="31337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relative abundance: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10288</a:t>
            </a:r>
          </a:p>
        </p:txBody>
      </p:sp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344632" y="107131"/>
            <a:ext cx="4261132" cy="987984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E11F31A-1082-43D8-906C-63034802E45C}"/>
              </a:ext>
            </a:extLst>
          </p:cNvPr>
          <p:cNvSpPr txBox="1"/>
          <p:nvPr/>
        </p:nvSpPr>
        <p:spPr>
          <a:xfrm>
            <a:off x="76200" y="723900"/>
            <a:ext cx="31337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4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ymphocyte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5FB39C9-E616-4F51-BE18-40FCDDFBEA72}"/>
              </a:ext>
            </a:extLst>
          </p:cNvPr>
          <p:cNvSpPr txBox="1"/>
          <p:nvPr/>
        </p:nvSpPr>
        <p:spPr>
          <a:xfrm>
            <a:off x="76201" y="1619250"/>
            <a:ext cx="31337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relative abundance: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13141</a:t>
            </a:r>
          </a:p>
        </p:txBody>
      </p:sp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344632" y="107131"/>
            <a:ext cx="4261132" cy="987984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CD1986B-1E52-4782-A806-F7D1981471EB}"/>
              </a:ext>
            </a:extLst>
          </p:cNvPr>
          <p:cNvSpPr txBox="1"/>
          <p:nvPr/>
        </p:nvSpPr>
        <p:spPr>
          <a:xfrm>
            <a:off x="76200" y="723900"/>
            <a:ext cx="31337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5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ad Cell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64BE8F9-81C9-459D-8CD2-338849AAC459}"/>
              </a:ext>
            </a:extLst>
          </p:cNvPr>
          <p:cNvSpPr txBox="1"/>
          <p:nvPr/>
        </p:nvSpPr>
        <p:spPr>
          <a:xfrm>
            <a:off x="76201" y="1619250"/>
            <a:ext cx="31337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relative abundance: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7078</a:t>
            </a:r>
          </a:p>
        </p:txBody>
      </p:sp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344632" y="107131"/>
            <a:ext cx="4261132" cy="987984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AABFA0E-5A9B-4926-A02C-92687F487E41}"/>
              </a:ext>
            </a:extLst>
          </p:cNvPr>
          <p:cNvSpPr txBox="1"/>
          <p:nvPr/>
        </p:nvSpPr>
        <p:spPr>
          <a:xfrm>
            <a:off x="76200" y="723900"/>
            <a:ext cx="31337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6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bri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8B413F2-0271-40E9-8F67-1CA9C63C3D14}"/>
              </a:ext>
            </a:extLst>
          </p:cNvPr>
          <p:cNvSpPr txBox="1"/>
          <p:nvPr/>
        </p:nvSpPr>
        <p:spPr>
          <a:xfrm>
            <a:off x="76201" y="1619250"/>
            <a:ext cx="31337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relative abundance: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38956</a:t>
            </a:r>
          </a:p>
        </p:txBody>
      </p:sp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344632" y="107131"/>
            <a:ext cx="4261132" cy="987984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A76CC95-99CC-4CE6-BBFE-D76511E2BCDB}"/>
              </a:ext>
            </a:extLst>
          </p:cNvPr>
          <p:cNvSpPr txBox="1"/>
          <p:nvPr/>
        </p:nvSpPr>
        <p:spPr>
          <a:xfrm>
            <a:off x="76200" y="723900"/>
            <a:ext cx="31337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7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genitor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EB8DB3B-A0BB-41E7-AA5D-803528F8471F}"/>
              </a:ext>
            </a:extLst>
          </p:cNvPr>
          <p:cNvSpPr txBox="1"/>
          <p:nvPr/>
        </p:nvSpPr>
        <p:spPr>
          <a:xfrm>
            <a:off x="76201" y="1619250"/>
            <a:ext cx="31337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relative abundance: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24669</a:t>
            </a:r>
          </a:p>
        </p:txBody>
      </p:sp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344632" y="107131"/>
            <a:ext cx="4261132" cy="987984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788E632-B989-480C-BC2C-0246CAE74F02}"/>
              </a:ext>
            </a:extLst>
          </p:cNvPr>
          <p:cNvSpPr txBox="1"/>
          <p:nvPr/>
        </p:nvSpPr>
        <p:spPr>
          <a:xfrm>
            <a:off x="76200" y="723900"/>
            <a:ext cx="31337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8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ythrocyte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D215B5A-F809-48B7-88E3-77B6602B8949}"/>
              </a:ext>
            </a:extLst>
          </p:cNvPr>
          <p:cNvSpPr txBox="1"/>
          <p:nvPr/>
        </p:nvSpPr>
        <p:spPr>
          <a:xfrm>
            <a:off x="76201" y="1619250"/>
            <a:ext cx="31337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relative abundance: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09445</a:t>
            </a:r>
          </a:p>
        </p:txBody>
      </p:sp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344632" y="107131"/>
            <a:ext cx="4261132" cy="987984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038BCA2-D14D-4225-A0C1-F7E0AE609287}"/>
              </a:ext>
            </a:extLst>
          </p:cNvPr>
          <p:cNvSpPr txBox="1"/>
          <p:nvPr/>
        </p:nvSpPr>
        <p:spPr>
          <a:xfrm>
            <a:off x="76200" y="723900"/>
            <a:ext cx="31337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uster 9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ymphocytes / Progenitor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7745BD0-38FF-4AD3-9F60-C8ABF0E62A49}"/>
              </a:ext>
            </a:extLst>
          </p:cNvPr>
          <p:cNvSpPr txBox="1"/>
          <p:nvPr/>
        </p:nvSpPr>
        <p:spPr>
          <a:xfrm>
            <a:off x="76201" y="1619250"/>
            <a:ext cx="31337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relative abundance:</a:t>
            </a:r>
          </a:p>
          <a:p>
            <a:pPr algn="ctr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351837</a:t>
            </a:r>
          </a:p>
        </p:txBody>
      </p:sp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181</Words>
  <Application>Microsoft Office PowerPoint</Application>
  <PresentationFormat>Custom</PresentationFormat>
  <Paragraphs>84</Paragraphs>
  <Slides>2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1</vt:i4>
      </vt:variant>
    </vt:vector>
  </HeadingPairs>
  <TitlesOfParts>
    <vt:vector size="26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CS Express Layout</dc:title>
  <dc:creator>FCS Express</dc:creator>
  <cp:lastModifiedBy>robert peuß</cp:lastModifiedBy>
  <cp:revision>5</cp:revision>
  <dcterms:created xsi:type="dcterms:W3CDTF">2015-10-19T23:50:05Z</dcterms:created>
  <dcterms:modified xsi:type="dcterms:W3CDTF">2019-03-10T22:40:48Z</dcterms:modified>
</cp:coreProperties>
</file>